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1F9FC-3060-42F4-B43B-CCA0A294D7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CC682-8B4A-4E85-A565-419A3C855B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B5E11-13B7-4D3E-98B2-1C20ADDC22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7BBDC-1C25-4010-B6B0-C7CB4E7297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6524B-DD1C-4904-9028-56C8207FF9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C7A43-FA00-40AE-BE85-4B7137DDB3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F82D5-5B71-4016-88EF-CF672027E2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6E109-7116-451A-9B90-63F92BA1F2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7F43F-7F80-41ED-BF5D-2067D608B2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D7991-9400-49A0-808B-822D6A9C61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AA453-1E98-41D3-B306-A096B6BCB6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3B499-36B4-4427-BCA7-06BAEE5A9C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57AD54-78DA-4DAF-8980-EC5EB15B5E8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"/>
          <p:cNvSpPr/>
          <p:nvPr/>
        </p:nvSpPr>
        <p:spPr>
          <a:xfrm>
            <a:off x="838080" y="5791320"/>
            <a:ext cx="7925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. Flow chart of study selection by using electronic databas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1219320" y="762120"/>
            <a:ext cx="2971800" cy="642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 potentially relevant articles identified up to April 20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1401840" y="2859120"/>
            <a:ext cx="2514600" cy="642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 articles retrieved for further evalu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4221000" y="1494000"/>
            <a:ext cx="4114800" cy="11912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8 articles excluded (by title and abstract)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 duplica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  not related to CCND1 and NP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  meta-analysis and revie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4237200" y="3613320"/>
            <a:ext cx="3276360" cy="11912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articles excluded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 overlapped with other stud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 associations with overall head       and neck cance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1600200" y="4964040"/>
            <a:ext cx="2133720" cy="3682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 articles includ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直接箭头连接符 16"/>
          <p:cNvCxnSpPr/>
          <p:nvPr/>
        </p:nvCxnSpPr>
        <p:spPr>
          <a:xfrm>
            <a:off x="2666880" y="2087280"/>
            <a:ext cx="154872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8" name="直接箭头连接符 18"/>
          <p:cNvCxnSpPr/>
          <p:nvPr/>
        </p:nvCxnSpPr>
        <p:spPr>
          <a:xfrm>
            <a:off x="2666520" y="1415520"/>
            <a:ext cx="1080" cy="14043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直接箭头连接符 22"/>
          <p:cNvCxnSpPr/>
          <p:nvPr/>
        </p:nvCxnSpPr>
        <p:spPr>
          <a:xfrm>
            <a:off x="2666880" y="4190760"/>
            <a:ext cx="154872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直接箭头连接符 23"/>
          <p:cNvCxnSpPr/>
          <p:nvPr/>
        </p:nvCxnSpPr>
        <p:spPr>
          <a:xfrm>
            <a:off x="2666520" y="3519000"/>
            <a:ext cx="1080" cy="14043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admin</cp:lastModifiedBy>
  <dcterms:modified xsi:type="dcterms:W3CDTF">2014-06-18T03:57:55Z</dcterms:modified>
  <cp:revision>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